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51E48-7A4A-4B9F-8DC0-EE9CD84EAA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05D18-CC7C-44BC-98E1-E6775DEB07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AD2FA-3B70-4444-89C1-FF6BF90E647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AF28C-F149-4F47-BE3E-1EE4B75C50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0982A-AFB8-4C82-B6E5-2B6978A703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5CA0E-CA89-4B02-8188-0DF9D02020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8A768-D7EE-4FA7-9F4A-AE3A39D663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4AD9F-8ECD-4F53-BED1-F5C629BF50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F75FD-B244-41A5-A531-E6171BFDF7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15EE5-ECE6-4A3D-84BA-834067C4DC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E9556-69C4-4606-A4C9-EAEEF972D4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05A93-44B8-465D-9515-1289C13541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871F57-1CBF-4705-A45E-EBD9EBA52E48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139"/>
          <p:cNvSpPr/>
          <p:nvPr/>
        </p:nvSpPr>
        <p:spPr>
          <a:xfrm>
            <a:off x="468360" y="500040"/>
            <a:ext cx="728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11. Predicted transcription factors possibly activated in heat shock or MG132 treated  RIF-1 and TR cells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 Box 1556"/>
          <p:cNvSpPr/>
          <p:nvPr/>
        </p:nvSpPr>
        <p:spPr>
          <a:xfrm>
            <a:off x="-3240" y="0"/>
            <a:ext cx="263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11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468360" y="787320"/>
          <a:ext cx="8209080" cy="5591160"/>
        </p:xfrm>
        <a:graphic>
          <a:graphicData uri="http://schemas.openxmlformats.org/drawingml/2006/table">
            <a:tbl>
              <a:tblPr/>
              <a:tblGrid>
                <a:gridCol w="936720"/>
                <a:gridCol w="1295280"/>
                <a:gridCol w="1728720"/>
                <a:gridCol w="714600"/>
                <a:gridCol w="500040"/>
                <a:gridCol w="225360"/>
                <a:gridCol w="1798560"/>
                <a:gridCol w="649440"/>
                <a:gridCol w="360360"/>
              </a:tblGrid>
              <a:tr h="200160">
                <a:tc rowSpan="2"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cover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F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2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dicted transcription facto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-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dicted transcription facto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val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31120">
                <a:tc rowSpan="3"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at shoc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.D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U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E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E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T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R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36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26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7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7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9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93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 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T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E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R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E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I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BP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F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AR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       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8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.D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4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 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.D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.D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93520">
                <a:tc rowSpan="3">
                  <a:txBody>
                    <a:bodyPr lIns="0" rIns="0" tIns="3600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G1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L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T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F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R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K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R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BP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*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02E-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L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F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E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BP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R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E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TS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*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96E-0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2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5 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.D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L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2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 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T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.D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직사각형 5"/>
          <p:cNvSpPr/>
          <p:nvPr/>
        </p:nvSpPr>
        <p:spPr>
          <a:xfrm>
            <a:off x="428760" y="6423120"/>
            <a:ext cx="457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.D.: not detected, *less than 0.0001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3T02:49:26Z</dcterms:created>
  <dc:creator>김희정</dc:creator>
  <dc:description/>
  <dc:language>en-US</dc:language>
  <cp:lastModifiedBy>김희정</cp:lastModifiedBy>
  <dcterms:modified xsi:type="dcterms:W3CDTF">2011-06-14T02:48:06Z</dcterms:modified>
  <cp:revision>200</cp:revision>
  <dc:subject/>
  <dc:title>슬라이드 1</dc:title>
</cp:coreProperties>
</file>